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290" r:id="rId2"/>
    <p:sldId id="291" r:id="rId3"/>
  </p:sldIdLst>
  <p:sldSz cx="9144000" cy="6858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5250" autoAdjust="0"/>
    <p:restoredTop sz="94660"/>
  </p:normalViewPr>
  <p:slideViewPr>
    <p:cSldViewPr>
      <p:cViewPr varScale="1">
        <p:scale>
          <a:sx n="104" d="100"/>
          <a:sy n="104" d="100"/>
        </p:scale>
        <p:origin x="-1240" y="-11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5" Type="http://schemas.openxmlformats.org/officeDocument/2006/relationships/handoutMaster" Target="handoutMasters/handoutMaster1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0" cy="493316"/>
          </a:xfrm>
          <a:prstGeom prst="rect">
            <a:avLst/>
          </a:prstGeom>
        </p:spPr>
        <p:txBody>
          <a:bodyPr vert="horz" lIns="91367" tIns="45683" rIns="91367" bIns="45683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5374" y="0"/>
            <a:ext cx="2918830" cy="493316"/>
          </a:xfrm>
          <a:prstGeom prst="rect">
            <a:avLst/>
          </a:prstGeom>
        </p:spPr>
        <p:txBody>
          <a:bodyPr vert="horz" lIns="91367" tIns="45683" rIns="91367" bIns="45683" rtlCol="0"/>
          <a:lstStyle>
            <a:lvl1pPr algn="r">
              <a:defRPr sz="1200"/>
            </a:lvl1pPr>
          </a:lstStyle>
          <a:p>
            <a:fld id="{D535260D-6164-4FA4-A39A-2CA7442C2EEB}" type="datetimeFigureOut">
              <a:rPr kumimoji="1" lang="ja-JP" altLang="en-US" smtClean="0"/>
              <a:t>17/02/0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371285"/>
            <a:ext cx="2918830" cy="493316"/>
          </a:xfrm>
          <a:prstGeom prst="rect">
            <a:avLst/>
          </a:prstGeom>
        </p:spPr>
        <p:txBody>
          <a:bodyPr vert="horz" lIns="91367" tIns="45683" rIns="91367" bIns="45683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5374" y="9371285"/>
            <a:ext cx="2918830" cy="493316"/>
          </a:xfrm>
          <a:prstGeom prst="rect">
            <a:avLst/>
          </a:prstGeom>
        </p:spPr>
        <p:txBody>
          <a:bodyPr vert="horz" lIns="91367" tIns="45683" rIns="91367" bIns="45683" rtlCol="0" anchor="b"/>
          <a:lstStyle>
            <a:lvl1pPr algn="r">
              <a:defRPr sz="1200"/>
            </a:lvl1pPr>
          </a:lstStyle>
          <a:p>
            <a:fld id="{0C5B1FA2-E424-4FC0-9B67-C393D6331F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926201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72E656-63B0-D14C-996C-A69514D49DE4}" type="datetimeFigureOut">
              <a:rPr kumimoji="1" lang="ja-JP" altLang="en-US" smtClean="0"/>
              <a:t>17/02/0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01700" y="739775"/>
            <a:ext cx="4932363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686300"/>
            <a:ext cx="5389563" cy="44402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013"/>
            <a:ext cx="2919413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1013"/>
            <a:ext cx="2919412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69328A6-DB09-CE4C-B70E-D89243D5C4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64771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F7D8126-C147-483C-86BD-F6DFA1E9DF1C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229125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F7D8126-C147-483C-86BD-F6DFA1E9DF1C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76737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1A0FF-6017-430C-AEC1-384AAA232656}" type="datetimeFigureOut">
              <a:rPr kumimoji="1" lang="ja-JP" altLang="en-US" smtClean="0"/>
              <a:t>17/02/0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10E2A-FF21-44A7-AFA5-B9FBCA7ED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4875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1A0FF-6017-430C-AEC1-384AAA232656}" type="datetimeFigureOut">
              <a:rPr kumimoji="1" lang="ja-JP" altLang="en-US" smtClean="0"/>
              <a:t>17/02/0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10E2A-FF21-44A7-AFA5-B9FBCA7ED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31729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1A0FF-6017-430C-AEC1-384AAA232656}" type="datetimeFigureOut">
              <a:rPr kumimoji="1" lang="ja-JP" altLang="en-US" smtClean="0"/>
              <a:t>17/02/0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10E2A-FF21-44A7-AFA5-B9FBCA7ED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43656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1A0FF-6017-430C-AEC1-384AAA232656}" type="datetimeFigureOut">
              <a:rPr kumimoji="1" lang="ja-JP" altLang="en-US" smtClean="0"/>
              <a:t>17/02/0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10E2A-FF21-44A7-AFA5-B9FBCA7ED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32052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1A0FF-6017-430C-AEC1-384AAA232656}" type="datetimeFigureOut">
              <a:rPr kumimoji="1" lang="ja-JP" altLang="en-US" smtClean="0"/>
              <a:t>17/02/0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10E2A-FF21-44A7-AFA5-B9FBCA7ED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96613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1A0FF-6017-430C-AEC1-384AAA232656}" type="datetimeFigureOut">
              <a:rPr kumimoji="1" lang="ja-JP" altLang="en-US" smtClean="0"/>
              <a:t>17/02/0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10E2A-FF21-44A7-AFA5-B9FBCA7ED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8511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1A0FF-6017-430C-AEC1-384AAA232656}" type="datetimeFigureOut">
              <a:rPr kumimoji="1" lang="ja-JP" altLang="en-US" smtClean="0"/>
              <a:t>17/02/0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10E2A-FF21-44A7-AFA5-B9FBCA7ED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88367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1A0FF-6017-430C-AEC1-384AAA232656}" type="datetimeFigureOut">
              <a:rPr kumimoji="1" lang="ja-JP" altLang="en-US" smtClean="0"/>
              <a:t>17/02/0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10E2A-FF21-44A7-AFA5-B9FBCA7ED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75422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1A0FF-6017-430C-AEC1-384AAA232656}" type="datetimeFigureOut">
              <a:rPr kumimoji="1" lang="ja-JP" altLang="en-US" smtClean="0"/>
              <a:t>17/02/0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10E2A-FF21-44A7-AFA5-B9FBCA7ED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26900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1A0FF-6017-430C-AEC1-384AAA232656}" type="datetimeFigureOut">
              <a:rPr kumimoji="1" lang="ja-JP" altLang="en-US" smtClean="0"/>
              <a:t>17/02/0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10E2A-FF21-44A7-AFA5-B9FBCA7ED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59902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91A0FF-6017-430C-AEC1-384AAA232656}" type="datetimeFigureOut">
              <a:rPr kumimoji="1" lang="ja-JP" altLang="en-US" smtClean="0"/>
              <a:t>17/02/0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10E2A-FF21-44A7-AFA5-B9FBCA7ED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89437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91A0FF-6017-430C-AEC1-384AAA232656}" type="datetimeFigureOut">
              <a:rPr kumimoji="1" lang="ja-JP" altLang="en-US" smtClean="0"/>
              <a:t>17/02/0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B10E2A-FF21-44A7-AFA5-B9FBCA7EDB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31486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タイトル 1"/>
          <p:cNvSpPr txBox="1">
            <a:spLocks/>
          </p:cNvSpPr>
          <p:nvPr/>
        </p:nvSpPr>
        <p:spPr>
          <a:xfrm>
            <a:off x="827584" y="107588"/>
            <a:ext cx="8229600" cy="615672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ja-JP" altLang="en-US" sz="2800" b="1" dirty="0" smtClean="0"/>
              <a:t>調査票</a:t>
            </a:r>
            <a:r>
              <a:rPr lang="en-US" altLang="ja-JP" sz="2800" b="1" dirty="0" smtClean="0"/>
              <a:t>  A</a:t>
            </a:r>
            <a:r>
              <a:rPr lang="ja-JP" altLang="en-US" sz="2800" b="1" dirty="0" smtClean="0"/>
              <a:t>　</a:t>
            </a:r>
            <a:r>
              <a:rPr lang="ja-JP" altLang="en-US" sz="2400" b="1" dirty="0" smtClean="0"/>
              <a:t>精神的項目</a:t>
            </a:r>
            <a:endParaRPr lang="ja-JP" altLang="en-US" sz="2400" b="1" dirty="0"/>
          </a:p>
        </p:txBody>
      </p:sp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87751736"/>
              </p:ext>
            </p:extLst>
          </p:nvPr>
        </p:nvGraphicFramePr>
        <p:xfrm>
          <a:off x="899592" y="681226"/>
          <a:ext cx="7488832" cy="6138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00647"/>
                <a:gridCol w="2316346"/>
                <a:gridCol w="1024931"/>
                <a:gridCol w="293813"/>
                <a:gridCol w="2384673"/>
                <a:gridCol w="1168422"/>
              </a:tblGrid>
              <a:tr h="26964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 dirty="0">
                          <a:effectLst/>
                        </a:rPr>
                        <a:t>1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 dirty="0">
                          <a:effectLst/>
                        </a:rPr>
                        <a:t>ものわすれ　</a:t>
                      </a:r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22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>
                          <a:effectLst/>
                        </a:rPr>
                        <a:t>ホスピスはいつ行ったらいいか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</a:tr>
              <a:tr h="264559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2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>
                          <a:effectLst/>
                        </a:rPr>
                        <a:t>気分が沈む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 dirty="0">
                          <a:effectLst/>
                        </a:rPr>
                        <a:t>  なし　　あり</a:t>
                      </a:r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 dirty="0">
                          <a:effectLst/>
                        </a:rPr>
                        <a:t>23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>
                          <a:effectLst/>
                        </a:rPr>
                        <a:t>衣類が合わなくなる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</a:tr>
              <a:tr h="264559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3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>
                          <a:effectLst/>
                        </a:rPr>
                        <a:t>気分がすぐれない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2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>
                          <a:effectLst/>
                        </a:rPr>
                        <a:t>仕事（家事）への影響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</a:tr>
              <a:tr h="26964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 dirty="0">
                          <a:effectLst/>
                        </a:rPr>
                        <a:t>興奮しやすい　</a:t>
                      </a:r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25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>
                          <a:effectLst/>
                        </a:rPr>
                        <a:t>家族への影響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</a:tr>
              <a:tr h="26964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 dirty="0">
                          <a:effectLst/>
                        </a:rPr>
                        <a:t>5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 dirty="0">
                          <a:effectLst/>
                        </a:rPr>
                        <a:t>考え方が前向きになれない　</a:t>
                      </a:r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26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>
                          <a:effectLst/>
                        </a:rPr>
                        <a:t>社会復帰への不安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</a:tr>
              <a:tr h="26964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6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>
                          <a:effectLst/>
                        </a:rPr>
                        <a:t>意欲がわかない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27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>
                          <a:effectLst/>
                        </a:rPr>
                        <a:t>社会活動への影響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</a:tr>
              <a:tr h="26964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7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>
                          <a:effectLst/>
                        </a:rPr>
                        <a:t>メソメソする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 dirty="0">
                          <a:effectLst/>
                        </a:rPr>
                        <a:t>  なし　　あり</a:t>
                      </a:r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28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>
                          <a:effectLst/>
                        </a:rPr>
                        <a:t>治療にかかる時間が負担だった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</a:tr>
              <a:tr h="26964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8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>
                          <a:effectLst/>
                        </a:rPr>
                        <a:t>イライラする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29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>
                          <a:effectLst/>
                        </a:rPr>
                        <a:t>自分以外の身内の看病、介護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</a:tr>
              <a:tr h="26964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9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>
                          <a:effectLst/>
                        </a:rPr>
                        <a:t>ものごとに集中できない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30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>
                          <a:effectLst/>
                        </a:rPr>
                        <a:t>生ものを食べることができない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</a:tr>
              <a:tr h="26964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10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>
                          <a:effectLst/>
                        </a:rPr>
                        <a:t>漠然とした恐怖感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3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>
                          <a:effectLst/>
                        </a:rPr>
                        <a:t>結婚できるか（未婚者）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</a:tr>
              <a:tr h="264559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1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>
                          <a:effectLst/>
                        </a:rPr>
                        <a:t>死への恐怖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32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>
                          <a:effectLst/>
                        </a:rPr>
                        <a:t>出産や育児、子供への影響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</a:tr>
              <a:tr h="26964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12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>
                          <a:effectLst/>
                        </a:rPr>
                        <a:t>何が起こっているか理解できない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33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>
                          <a:effectLst/>
                        </a:rPr>
                        <a:t>不妊に対する不安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</a:tr>
              <a:tr h="26964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13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>
                          <a:effectLst/>
                        </a:rPr>
                        <a:t>治療への不安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3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>
                          <a:effectLst/>
                        </a:rPr>
                        <a:t>性欲減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</a:tr>
              <a:tr h="26964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1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>
                          <a:effectLst/>
                        </a:rPr>
                        <a:t>次の治療に向けて体調が回復するかどうかの不安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35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>
                          <a:effectLst/>
                        </a:rPr>
                        <a:t>通院時間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</a:tr>
              <a:tr h="26964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15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 dirty="0">
                          <a:effectLst/>
                        </a:rPr>
                        <a:t>人生の不安 （漠然とした不安）</a:t>
                      </a:r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36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>
                          <a:effectLst/>
                        </a:rPr>
                        <a:t>医療費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</a:tr>
              <a:tr h="26964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16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>
                          <a:effectLst/>
                        </a:rPr>
                        <a:t>相談相手がいない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37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>
                          <a:effectLst/>
                        </a:rPr>
                        <a:t>医療者との関係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</a:tr>
              <a:tr h="24420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17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 dirty="0">
                          <a:effectLst/>
                        </a:rPr>
                        <a:t>支えてくれる人がいない</a:t>
                      </a:r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38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 dirty="0">
                          <a:effectLst/>
                        </a:rPr>
                        <a:t>他の患者との関係</a:t>
                      </a:r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</a:tr>
              <a:tr h="32561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18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>
                          <a:effectLst/>
                        </a:rPr>
                        <a:t>人に病気のことを知られたくない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39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 dirty="0">
                          <a:effectLst/>
                        </a:rPr>
                        <a:t>医療機関とのトラブル</a:t>
                      </a:r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</a:tr>
              <a:tr h="28999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19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>
                          <a:effectLst/>
                        </a:rPr>
                        <a:t>主治医が変わることへの不満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40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 dirty="0">
                          <a:effectLst/>
                        </a:rPr>
                        <a:t>医療者への連絡方法</a:t>
                      </a:r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</a:tr>
              <a:tr h="264559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20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>
                          <a:effectLst/>
                        </a:rPr>
                        <a:t>インターネットなどの情報の信用性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4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 dirty="0">
                          <a:effectLst/>
                        </a:rPr>
                        <a:t>医療者に連絡してもいいのか</a:t>
                      </a:r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</a:tr>
              <a:tr h="32052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2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>
                          <a:effectLst/>
                        </a:rPr>
                        <a:t>セカンドオピニオンを受けたいが主治医に気を遣う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u="none" strike="noStrike">
                          <a:effectLst/>
                        </a:rPr>
                        <a:t>42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u="none" strike="noStrike">
                          <a:effectLst/>
                        </a:rPr>
                        <a:t>その他（　　　　　　　　　　）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b="0" u="none" strike="noStrike">
                          <a:effectLst/>
                        </a:rPr>
                        <a:t>  なし　　あり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</a:tr>
              <a:tr h="330698">
                <a:tc gridSpan="6">
                  <a:txBody>
                    <a:bodyPr/>
                    <a:lstStyle/>
                    <a:p>
                      <a:pPr algn="l" fontAlgn="ctr"/>
                      <a:r>
                        <a:rPr lang="en-US" altLang="ja-JP" sz="1050" b="0" u="none" strike="noStrike" dirty="0">
                          <a:effectLst/>
                        </a:rPr>
                        <a:t>1</a:t>
                      </a:r>
                      <a:r>
                        <a:rPr lang="ja-JP" altLang="en-US" sz="1050" b="0" u="none" strike="noStrike" dirty="0">
                          <a:effectLst/>
                        </a:rPr>
                        <a:t>～</a:t>
                      </a:r>
                      <a:r>
                        <a:rPr lang="en-US" altLang="ja-JP" sz="1050" b="0" u="none" strike="noStrike" dirty="0">
                          <a:effectLst/>
                        </a:rPr>
                        <a:t>42</a:t>
                      </a:r>
                      <a:r>
                        <a:rPr lang="ja-JP" altLang="en-US" sz="1050" b="0" u="none" strike="noStrike" dirty="0">
                          <a:effectLst/>
                        </a:rPr>
                        <a:t>番の中で辛かった悩んだ項目を上位３つ番号を選んでください</a:t>
                      </a:r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HG丸ｺﾞｼｯｸM-PRO"/>
                      </a:endParaRPr>
                    </a:p>
                  </a:txBody>
                  <a:tcPr marL="3791" marR="3791" marT="3791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2" name="テキスト ボックス 1"/>
          <p:cNvSpPr txBox="1"/>
          <p:nvPr/>
        </p:nvSpPr>
        <p:spPr>
          <a:xfrm>
            <a:off x="1331640" y="116632"/>
            <a:ext cx="17316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/>
              <a:t>Supplement 1.</a:t>
            </a:r>
            <a:endParaRPr kumimoji="1" lang="ja-JP" alt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423842623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 txBox="1">
            <a:spLocks/>
          </p:cNvSpPr>
          <p:nvPr/>
        </p:nvSpPr>
        <p:spPr>
          <a:xfrm>
            <a:off x="323528" y="-18708"/>
            <a:ext cx="8229600" cy="615672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ja-JP" altLang="en-US" sz="2000" b="1" dirty="0" smtClean="0"/>
              <a:t>調査票　</a:t>
            </a:r>
            <a:r>
              <a:rPr lang="en-US" altLang="ja-JP" sz="2000" b="1" dirty="0" smtClean="0"/>
              <a:t>B</a:t>
            </a:r>
            <a:r>
              <a:rPr lang="ja-JP" altLang="en-US" sz="2000" b="1" dirty="0" smtClean="0"/>
              <a:t>　</a:t>
            </a:r>
            <a:r>
              <a:rPr lang="ja-JP" altLang="en-US" sz="2000" b="1" dirty="0"/>
              <a:t>身体</a:t>
            </a:r>
            <a:r>
              <a:rPr lang="ja-JP" altLang="en-US" sz="2000" b="1" dirty="0" smtClean="0"/>
              <a:t>的項目</a:t>
            </a:r>
            <a:endParaRPr lang="ja-JP" altLang="en-US" sz="2000" b="1" dirty="0"/>
          </a:p>
        </p:txBody>
      </p:sp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5085905"/>
              </p:ext>
            </p:extLst>
          </p:nvPr>
        </p:nvGraphicFramePr>
        <p:xfrm>
          <a:off x="1403648" y="339285"/>
          <a:ext cx="6094268" cy="651871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59031"/>
                <a:gridCol w="1765028"/>
                <a:gridCol w="1024077"/>
                <a:gridCol w="257024"/>
                <a:gridCol w="1783101"/>
                <a:gridCol w="1006007"/>
              </a:tblGrid>
              <a:tr h="197019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43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吐き気　</a:t>
                      </a:r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69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排尿時痛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</a:tr>
              <a:tr h="197019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嘔吐（実際に吐いた）　</a:t>
                      </a:r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70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排尿困難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</a:tr>
              <a:tr h="21453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5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便秘　</a:t>
                      </a:r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7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鼻出血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</a:tr>
              <a:tr h="197019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6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下痢　</a:t>
                      </a:r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72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頭痛</a:t>
                      </a:r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</a:tr>
              <a:tr h="22766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7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味覚（味）がいつもと違う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73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めまい　</a:t>
                      </a:r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</a:tr>
              <a:tr h="218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8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食べ物の味がしなくなった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7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たちくらみ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</a:tr>
              <a:tr h="22766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9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食欲が無くなった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75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耳鳴り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</a:tr>
              <a:tr h="22766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50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のどの痛み</a:t>
                      </a:r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76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耳の聴こえ難さ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</a:tr>
              <a:tr h="23204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5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お腹の痛み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77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あざができやすい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</a:tr>
              <a:tr h="23204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52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お腹がはってきつい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78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じんま疹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</a:tr>
              <a:tr h="23204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53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のどの渇き　</a:t>
                      </a:r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79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肌の色の変化（黒ずみ）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</a:tr>
              <a:tr h="2838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5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においの変化　</a:t>
                      </a:r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80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爪の変化</a:t>
                      </a:r>
                      <a:b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</a:b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（色、痛み、割れたなど）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</a:tr>
              <a:tr h="23204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55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口内炎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8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ほてり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</a:tr>
              <a:tr h="28383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56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食欲が増した　</a:t>
                      </a:r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82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にきび</a:t>
                      </a:r>
                      <a:b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</a:b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（皮疹：湿疹のようなもの）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</a:tr>
              <a:tr h="23204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57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口角炎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83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肌の乾燥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</a:tr>
              <a:tr h="22766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58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飲み込みにくい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8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かゆみ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</a:tr>
              <a:tr h="31439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59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しびれ（部位　　　　　   ）</a:t>
                      </a:r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85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日光アレルギー様皮膚炎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</a:tr>
              <a:tr h="23204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60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手先・足先の痛み　</a:t>
                      </a:r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86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発熱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</a:tr>
              <a:tr h="23204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6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感覚の鈍さ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87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倦怠感（体がきつい）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</a:tr>
              <a:tr h="23204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62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050" u="none" strike="noStrike" kern="1200" dirty="0" smtClean="0">
                          <a:solidFill>
                            <a:schemeClr val="dk1"/>
                          </a:solidFill>
                          <a:effectLst/>
                          <a:latin typeface="+mj-ea"/>
                          <a:ea typeface="+mn-ea"/>
                          <a:cs typeface="+mn-cs"/>
                        </a:rPr>
                        <a:t>知覚過敏（部位　　　　　   ）</a:t>
                      </a:r>
                      <a:r>
                        <a:rPr lang="zh-TW" altLang="en-US" sz="1050" u="none" strike="noStrike" dirty="0">
                          <a:effectLst/>
                          <a:latin typeface="+mj-ea"/>
                          <a:ea typeface="+mj-ea"/>
                        </a:rPr>
                        <a:t>　</a:t>
                      </a:r>
                      <a:endParaRPr lang="zh-TW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88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脱毛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</a:tr>
              <a:tr h="23204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63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注射部位の痛み</a:t>
                      </a:r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89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体重減少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</a:tr>
              <a:tr h="21015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6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血管が出ない不安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/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恐怖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90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体重増加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</a:tr>
              <a:tr h="28020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65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関節痛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9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むくみ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</a:tr>
              <a:tr h="24955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66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筋肉痛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92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動悸　</a:t>
                      </a:r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</a:tr>
              <a:tr h="22766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67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尿の色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93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息切れ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</a:tr>
              <a:tr h="27582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+mj-ea"/>
                          <a:ea typeface="+mj-ea"/>
                        </a:rPr>
                        <a:t>68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>
                          <a:effectLst/>
                          <a:latin typeface="+mj-ea"/>
                          <a:ea typeface="+mj-ea"/>
                        </a:rPr>
                        <a:t>尿量の変化　</a:t>
                      </a:r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94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不眠　</a:t>
                      </a:r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0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1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2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3</a:t>
                      </a:r>
                      <a:r>
                        <a:rPr lang="ja-JP" altLang="en-US" sz="1050" u="none" strike="noStrike" dirty="0">
                          <a:effectLst/>
                          <a:latin typeface="+mj-ea"/>
                          <a:ea typeface="+mj-ea"/>
                        </a:rPr>
                        <a:t>・</a:t>
                      </a:r>
                      <a:r>
                        <a:rPr lang="en-US" altLang="ja-JP" sz="1050" u="none" strike="noStrike" dirty="0">
                          <a:effectLst/>
                          <a:latin typeface="+mj-ea"/>
                          <a:ea typeface="+mj-ea"/>
                        </a:rPr>
                        <a:t>4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</a:tr>
              <a:tr h="284584">
                <a:tc gridSpan="6">
                  <a:txBody>
                    <a:bodyPr/>
                    <a:lstStyle/>
                    <a:p>
                      <a:pPr algn="l" fontAlgn="ctr"/>
                      <a:r>
                        <a:rPr lang="en-US" altLang="ja-JP" sz="1100" u="none" strike="noStrike" dirty="0">
                          <a:effectLst/>
                          <a:latin typeface="+mj-ea"/>
                          <a:ea typeface="+mj-ea"/>
                        </a:rPr>
                        <a:t>43</a:t>
                      </a:r>
                      <a:r>
                        <a:rPr lang="ja-JP" altLang="en-US" sz="1100" u="none" strike="noStrike" dirty="0">
                          <a:effectLst/>
                          <a:latin typeface="+mj-ea"/>
                          <a:ea typeface="+mj-ea"/>
                        </a:rPr>
                        <a:t>～</a:t>
                      </a:r>
                      <a:r>
                        <a:rPr lang="en-US" altLang="ja-JP" sz="1100" u="none" strike="noStrike" dirty="0">
                          <a:effectLst/>
                          <a:latin typeface="+mj-ea"/>
                          <a:ea typeface="+mj-ea"/>
                        </a:rPr>
                        <a:t>94</a:t>
                      </a:r>
                      <a:r>
                        <a:rPr lang="ja-JP" altLang="en-US" sz="1100" u="none" strike="noStrike" dirty="0">
                          <a:effectLst/>
                          <a:latin typeface="+mj-ea"/>
                          <a:ea typeface="+mj-ea"/>
                        </a:rPr>
                        <a:t>番の中で辛かった悩んだ項目を上位３つ番号を選んでください</a:t>
                      </a:r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j-ea"/>
                        <a:ea typeface="+mj-ea"/>
                      </a:endParaRPr>
                    </a:p>
                  </a:txBody>
                  <a:tcPr marL="3165" marR="3165" marT="3165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8" name="テキスト ボックス 7"/>
          <p:cNvSpPr txBox="1"/>
          <p:nvPr/>
        </p:nvSpPr>
        <p:spPr>
          <a:xfrm>
            <a:off x="1331640" y="-67454"/>
            <a:ext cx="17316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/>
              <a:t>Supplement 2.</a:t>
            </a:r>
            <a:endParaRPr kumimoji="1" lang="ja-JP" alt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319095003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39</TotalTime>
  <Words>989</Words>
  <Application>Microsoft Macintosh PowerPoint</Application>
  <PresentationFormat>画面に合わせる (4:3)</PresentationFormat>
  <Paragraphs>290</Paragraphs>
  <Slides>2</Slides>
  <Notes>2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Office ​​テーマ</vt:lpstr>
      <vt:lpstr>PowerPoint プレゼンテーション</vt:lpstr>
      <vt:lpstr>PowerPoint プレゼンテーション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professor</dc:creator>
  <cp:lastModifiedBy>ササキ ヒデノリ</cp:lastModifiedBy>
  <cp:revision>92</cp:revision>
  <cp:lastPrinted>2016-02-17T08:43:48Z</cp:lastPrinted>
  <dcterms:created xsi:type="dcterms:W3CDTF">2016-01-12T07:01:49Z</dcterms:created>
  <dcterms:modified xsi:type="dcterms:W3CDTF">2017-02-04T00:52:54Z</dcterms:modified>
</cp:coreProperties>
</file>